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9.png" ContentType="image/png"/>
  <Override PartName="/ppt/media/image27.png" ContentType="image/png"/>
  <Override PartName="/ppt/media/image26.png" ContentType="image/png"/>
  <Override PartName="/ppt/media/image24.png" ContentType="image/png"/>
  <Override PartName="/ppt/media/image11.jpeg" ContentType="image/jpeg"/>
  <Override PartName="/ppt/media/image22.png" ContentType="image/png"/>
  <Override PartName="/ppt/media/image21.png" ContentType="image/png"/>
  <Override PartName="/ppt/media/image19.png" ContentType="image/png"/>
  <Override PartName="/ppt/media/image17.png" ContentType="image/png"/>
  <Override PartName="/ppt/media/image32.jpeg" ContentType="image/jpeg"/>
  <Override PartName="/ppt/media/image16.png" ContentType="image/png"/>
  <Override PartName="/ppt/media/image49.jpeg" ContentType="image/jpeg"/>
  <Override PartName="/ppt/media/image15.jpeg" ContentType="image/jpeg"/>
  <Override PartName="/ppt/media/image14.jpeg" ContentType="image/jpeg"/>
  <Override PartName="/ppt/media/image54.png" ContentType="image/png"/>
  <Override PartName="/ppt/media/image1.jpeg" ContentType="image/jpeg"/>
  <Override PartName="/ppt/media/image47.png" ContentType="image/png"/>
  <Override PartName="/ppt/media/image2.jpeg" ContentType="image/jpeg"/>
  <Override PartName="/ppt/media/image20.png" ContentType="image/png"/>
  <Override PartName="/ppt/media/image3.jpeg" ContentType="image/jpeg"/>
  <Override PartName="/ppt/media/image30.png" ContentType="image/png"/>
  <Override PartName="/ppt/media/image25.png" ContentType="image/png"/>
  <Override PartName="/ppt/media/image4.jpeg" ContentType="image/jpeg"/>
  <Override PartName="/ppt/media/image40.png" ContentType="image/png"/>
  <Override PartName="/ppt/media/image5.jpeg" ContentType="image/jpeg"/>
  <Override PartName="/ppt/media/image37.png" ContentType="image/png"/>
  <Override PartName="/ppt/media/image48.jpeg" ContentType="image/jpeg"/>
  <Override PartName="/ppt/media/image39.png" ContentType="image/png"/>
  <Override PartName="/ppt/media/image41.png" ContentType="image/png"/>
  <Override PartName="/ppt/media/image42.png" ContentType="image/png"/>
  <Override PartName="/ppt/media/image46.png" ContentType="image/png"/>
  <Override PartName="/ppt/media/image50.jpeg" ContentType="image/jpeg"/>
  <Override PartName="/ppt/media/image52.png" ContentType="image/png"/>
  <Override PartName="/ppt/media/image45.png" ContentType="image/png"/>
  <Override PartName="/ppt/media/image51.jpeg" ContentType="image/jpeg"/>
  <Override PartName="/ppt/media/image23.png" ContentType="image/png"/>
  <Override PartName="/ppt/media/image53.png" ContentType="image/png"/>
  <Override PartName="/ppt/media/image43.png" ContentType="image/png"/>
  <Override PartName="/ppt/media/image55.png" ContentType="image/png"/>
  <Override PartName="/ppt/media/image6.jpeg" ContentType="image/jpeg"/>
  <Override PartName="/ppt/media/image18.png" ContentType="image/png"/>
  <Override PartName="/ppt/media/image36.png" ContentType="image/png"/>
  <Override PartName="/ppt/media/image35.png" ContentType="image/png"/>
  <Override PartName="/ppt/media/image33.png" ContentType="image/png"/>
  <Override PartName="/ppt/media/image31.png" ContentType="image/png"/>
  <Override PartName="/ppt/media/image9.jpeg" ContentType="image/jpeg"/>
  <Override PartName="/ppt/media/image13.jpeg" ContentType="image/jpeg"/>
  <Override PartName="/ppt/media/image44.png" ContentType="image/png"/>
  <Override PartName="/ppt/media/image38.png" ContentType="image/png"/>
  <Override PartName="/ppt/media/image8.jpeg" ContentType="image/jpeg"/>
  <Override PartName="/ppt/media/image10.jpeg" ContentType="image/jpeg"/>
  <Override PartName="/ppt/media/image7.jpeg" ContentType="image/jpeg"/>
  <Override PartName="/ppt/media/image28.png" ContentType="image/png"/>
  <Override PartName="/ppt/media/image12.jpeg" ContentType="image/jpeg"/>
  <Override PartName="/ppt/media/image34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13716000" cy="17373600"/>
  <p:notesSz cx="6889750" cy="100218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90400" cy="10022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86200" cy="50328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Autofit/>
          </a:bodyPr>
          <a:p>
            <a:pPr indent="0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901680" y="0"/>
            <a:ext cx="2986200" cy="50328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Autofit/>
          </a:bodyPr>
          <a:lstStyle>
            <a:lvl1pPr indent="0" algn="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  <a:defRPr b="0" lang="el-GR" sz="13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l-GR" sz="13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09600" y="1252080"/>
            <a:ext cx="2670120" cy="33829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6480" rIns="96480" tIns="48240" bIns="4824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85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9040" y="4822920"/>
            <a:ext cx="5511600" cy="394632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9518760"/>
            <a:ext cx="2986200" cy="50328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b">
            <a:noAutofit/>
          </a:bodyPr>
          <a:p>
            <a:pPr indent="0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901680" y="9518760"/>
            <a:ext cx="2986200" cy="50328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b">
            <a:noAutofit/>
          </a:bodyPr>
          <a:lstStyle>
            <a:lvl1pPr indent="0" algn="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  <a:defRPr b="0" lang="el-GR" sz="13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fld id="{C6F2E202-08E8-4B67-8D7E-CB878BB45BEB}" type="slidenum">
              <a:rPr b="0" lang="el-GR" sz="13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" name="PlaceHolder 1"/>
          <p:cNvSpPr>
            <a:spLocks noGrp="1"/>
          </p:cNvSpPr>
          <p:nvPr>
            <p:ph type="sldImg"/>
          </p:nvPr>
        </p:nvSpPr>
        <p:spPr>
          <a:xfrm>
            <a:off x="2109960" y="1252440"/>
            <a:ext cx="2670120" cy="3382920"/>
          </a:xfrm>
          <a:prstGeom prst="rect">
            <a:avLst/>
          </a:prstGeom>
          <a:ln w="0">
            <a:noFill/>
          </a:ln>
        </p:spPr>
      </p:sp>
      <p:sp>
        <p:nvSpPr>
          <p:cNvPr id="139" name="PlaceHolder 2"/>
          <p:cNvSpPr>
            <a:spLocks noGrp="1"/>
          </p:cNvSpPr>
          <p:nvPr>
            <p:ph type="body"/>
          </p:nvPr>
        </p:nvSpPr>
        <p:spPr>
          <a:xfrm>
            <a:off x="689040" y="4822920"/>
            <a:ext cx="5511600" cy="3946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Θέση αριθμού διαφάνειας 3"/>
          <p:cNvSpPr/>
          <p:nvPr/>
        </p:nvSpPr>
        <p:spPr>
          <a:xfrm>
            <a:off x="3902040" y="9518760"/>
            <a:ext cx="2986200" cy="50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 algn="r"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fld id="{62AEAB8B-7036-4FFD-A4F5-1C6A47173F3F}" type="slidenum">
              <a:rPr b="0" lang="el-GR" sz="13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PlaceHolder 1"/>
          <p:cNvSpPr>
            <a:spLocks noGrp="1"/>
          </p:cNvSpPr>
          <p:nvPr>
            <p:ph type="sldImg"/>
          </p:nvPr>
        </p:nvSpPr>
        <p:spPr>
          <a:xfrm>
            <a:off x="2109960" y="1252440"/>
            <a:ext cx="2670120" cy="3382920"/>
          </a:xfrm>
          <a:prstGeom prst="rect">
            <a:avLst/>
          </a:prstGeom>
          <a:ln w="0">
            <a:noFill/>
          </a:ln>
        </p:spPr>
      </p:sp>
      <p:sp>
        <p:nvSpPr>
          <p:cNvPr id="142" name="PlaceHolder 2"/>
          <p:cNvSpPr>
            <a:spLocks noGrp="1"/>
          </p:cNvSpPr>
          <p:nvPr>
            <p:ph type="body"/>
          </p:nvPr>
        </p:nvSpPr>
        <p:spPr>
          <a:xfrm>
            <a:off x="689040" y="4822920"/>
            <a:ext cx="5511600" cy="3946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Θέση αριθμού διαφάνειας 3"/>
          <p:cNvSpPr/>
          <p:nvPr/>
        </p:nvSpPr>
        <p:spPr>
          <a:xfrm>
            <a:off x="3902040" y="9518760"/>
            <a:ext cx="2986200" cy="50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 algn="r"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fld id="{96C187FC-FE35-4EB3-A1A6-4476528C3189}" type="slidenum">
              <a:rPr b="0" lang="el-GR" sz="13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11CBE7-023A-4436-9EF4-303CFE18760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1234440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10042200"/>
            <a:ext cx="1234440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502308-CB57-404C-B362-5E704930E77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7011360" y="405396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1004220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7011360" y="1004220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75A06E-23B3-4102-949B-1B3D8FF957D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397476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859640" y="4053960"/>
            <a:ext cx="397476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9033480" y="4053960"/>
            <a:ext cx="397476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10042200"/>
            <a:ext cx="397476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859640" y="10042200"/>
            <a:ext cx="397476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9033480" y="10042200"/>
            <a:ext cx="397476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10437B-0C71-46A2-94F0-6646D4EA41F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4053960"/>
            <a:ext cx="12344400" cy="11464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551"/>
              </a:spcBef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EF9F91-B7D1-47E4-AE5A-CC90852B123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12344400" cy="1146492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B7894F-D00F-435C-8A9A-FD92568CB92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6023880" cy="1146492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7011360" y="4053960"/>
            <a:ext cx="6023880" cy="1146492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B9F8AC-DE31-4E89-8CCD-516D571CC6E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BF10C0-9499-4D4E-A20E-53BB1AE8790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95160"/>
            <a:ext cx="12344400" cy="13424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551"/>
              </a:spcBef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5F6FFE-0DC2-4420-8434-AC9CDCB5DDE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7011360" y="4053960"/>
            <a:ext cx="6023880" cy="1146492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1004220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8EF2FD-D6CD-4496-9A4F-E68246839D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6023880" cy="1146492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7011360" y="405396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7011360" y="1004220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581BF4-8589-4C0B-BEC8-78703EE7D6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405396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7011360" y="4053960"/>
            <a:ext cx="602388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10042200"/>
            <a:ext cx="12344400" cy="546840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74ACD9-48E6-4410-A03A-6EB3431EB2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95160"/>
            <a:ext cx="12344400" cy="289584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 algn="ctr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85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4053960"/>
            <a:ext cx="12344400" cy="1146492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t">
            <a:normAutofit/>
          </a:bodyPr>
          <a:p>
            <a:pPr marL="665280" indent="-665280">
              <a:spcBef>
                <a:spcPts val="1551"/>
              </a:spcBef>
              <a:buClr>
                <a:srgbClr val="000000"/>
              </a:buClr>
              <a:buFont typeface="Arial"/>
              <a:buChar char="•"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  <a:p>
            <a:pPr lvl="1" marL="1442880" indent="-554040">
              <a:spcBef>
                <a:spcPts val="1551"/>
              </a:spcBef>
              <a:buClr>
                <a:srgbClr val="000000"/>
              </a:buClr>
              <a:buFont typeface="Arial"/>
              <a:buChar char="–"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  <a:p>
            <a:pPr lvl="2" marL="2219400" indent="-443160">
              <a:spcBef>
                <a:spcPts val="1551"/>
              </a:spcBef>
              <a:buClr>
                <a:srgbClr val="000000"/>
              </a:buClr>
              <a:buFont typeface="Arial"/>
              <a:buChar char="•"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  <a:p>
            <a:pPr lvl="3" marL="3108240" indent="-442800">
              <a:spcBef>
                <a:spcPts val="1551"/>
              </a:spcBef>
              <a:buClr>
                <a:srgbClr val="000000"/>
              </a:buClr>
              <a:buFont typeface="Arial"/>
              <a:buChar char="–"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  <a:p>
            <a:pPr lvl="4" marL="3995640" indent="-442800">
              <a:spcBef>
                <a:spcPts val="1551"/>
              </a:spcBef>
              <a:buClr>
                <a:srgbClr val="000000"/>
              </a:buClr>
              <a:buFont typeface="Arial"/>
              <a:buChar char="»"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  <a:p>
            <a:pPr lvl="5" marL="3995640" indent="-442800">
              <a:spcBef>
                <a:spcPts val="1551"/>
              </a:spcBef>
              <a:buClr>
                <a:srgbClr val="000000"/>
              </a:buClr>
              <a:buFont typeface="Arial"/>
              <a:buChar char="»"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  <a:p>
            <a:pPr lvl="6" marL="3995640" indent="-442800">
              <a:spcBef>
                <a:spcPts val="1551"/>
              </a:spcBef>
              <a:buClr>
                <a:srgbClr val="000000"/>
              </a:buClr>
              <a:buFont typeface="Arial"/>
              <a:buChar char="»"/>
              <a:tabLst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16101720"/>
            <a:ext cx="3200400" cy="92556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  <a:defRPr b="0" lang="en-US" sz="23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0" lang="en-US" sz="23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686120" y="16101720"/>
            <a:ext cx="4343400" cy="92556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p>
            <a:pPr indent="0"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endParaRPr b="0" lang="en-US" sz="3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9829800" y="16101720"/>
            <a:ext cx="3200400" cy="925560"/>
          </a:xfrm>
          <a:prstGeom prst="rect">
            <a:avLst/>
          </a:prstGeom>
          <a:noFill/>
          <a:ln w="0">
            <a:noFill/>
          </a:ln>
        </p:spPr>
        <p:txBody>
          <a:bodyPr lIns="177480" rIns="177480" tIns="88920" bIns="8892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  <a:defRPr b="0" lang="en-US" sz="23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fld id="{E576BB72-73F7-4926-B20E-6F10E2B6DF0F}" type="slidenum">
              <a:rPr b="0" lang="en-US" sz="23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image" Target="../media/image13.jpeg"/><Relationship Id="rId14" Type="http://schemas.openxmlformats.org/officeDocument/2006/relationships/image" Target="../media/image14.jpeg"/><Relationship Id="rId15" Type="http://schemas.openxmlformats.org/officeDocument/2006/relationships/image" Target="../media/image15.jpeg"/><Relationship Id="rId16" Type="http://schemas.openxmlformats.org/officeDocument/2006/relationships/slideLayout" Target="../slideLayouts/slideLayout1.xml"/><Relationship Id="rId17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image" Target="../media/image17.png"/><Relationship Id="rId3" Type="http://schemas.openxmlformats.org/officeDocument/2006/relationships/image" Target="../media/image18.png"/><Relationship Id="rId4" Type="http://schemas.openxmlformats.org/officeDocument/2006/relationships/image" Target="../media/image19.png"/><Relationship Id="rId5" Type="http://schemas.openxmlformats.org/officeDocument/2006/relationships/image" Target="../media/image20.png"/><Relationship Id="rId6" Type="http://schemas.openxmlformats.org/officeDocument/2006/relationships/image" Target="../media/image21.png"/><Relationship Id="rId7" Type="http://schemas.openxmlformats.org/officeDocument/2006/relationships/image" Target="../media/image22.png"/><Relationship Id="rId8" Type="http://schemas.openxmlformats.org/officeDocument/2006/relationships/image" Target="../media/image23.png"/><Relationship Id="rId9" Type="http://schemas.openxmlformats.org/officeDocument/2006/relationships/image" Target="../media/image24.png"/><Relationship Id="rId10" Type="http://schemas.openxmlformats.org/officeDocument/2006/relationships/image" Target="../media/image25.png"/><Relationship Id="rId11" Type="http://schemas.openxmlformats.org/officeDocument/2006/relationships/image" Target="../media/image26.png"/><Relationship Id="rId12" Type="http://schemas.openxmlformats.org/officeDocument/2006/relationships/image" Target="../media/image27.png"/><Relationship Id="rId13" Type="http://schemas.openxmlformats.org/officeDocument/2006/relationships/image" Target="../media/image28.png"/><Relationship Id="rId14" Type="http://schemas.openxmlformats.org/officeDocument/2006/relationships/image" Target="../media/image29.png"/><Relationship Id="rId15" Type="http://schemas.openxmlformats.org/officeDocument/2006/relationships/image" Target="../media/image30.png"/><Relationship Id="rId16" Type="http://schemas.openxmlformats.org/officeDocument/2006/relationships/image" Target="../media/image31.png"/><Relationship Id="rId17" Type="http://schemas.openxmlformats.org/officeDocument/2006/relationships/image" Target="../media/image32.jpeg"/><Relationship Id="rId18" Type="http://schemas.openxmlformats.org/officeDocument/2006/relationships/image" Target="../media/image33.png"/><Relationship Id="rId19" Type="http://schemas.openxmlformats.org/officeDocument/2006/relationships/image" Target="../media/image34.png"/><Relationship Id="rId20" Type="http://schemas.openxmlformats.org/officeDocument/2006/relationships/image" Target="../media/image35.png"/><Relationship Id="rId21" Type="http://schemas.openxmlformats.org/officeDocument/2006/relationships/image" Target="../media/image36.png"/><Relationship Id="rId22" Type="http://schemas.openxmlformats.org/officeDocument/2006/relationships/image" Target="../media/image37.png"/><Relationship Id="rId23" Type="http://schemas.openxmlformats.org/officeDocument/2006/relationships/image" Target="../media/image38.png"/><Relationship Id="rId24" Type="http://schemas.openxmlformats.org/officeDocument/2006/relationships/image" Target="../media/image39.png"/><Relationship Id="rId25" Type="http://schemas.openxmlformats.org/officeDocument/2006/relationships/image" Target="../media/image40.png"/><Relationship Id="rId26" Type="http://schemas.openxmlformats.org/officeDocument/2006/relationships/image" Target="../media/image41.png"/><Relationship Id="rId27" Type="http://schemas.openxmlformats.org/officeDocument/2006/relationships/image" Target="../media/image42.png"/><Relationship Id="rId28" Type="http://schemas.openxmlformats.org/officeDocument/2006/relationships/image" Target="../media/image43.png"/><Relationship Id="rId29" Type="http://schemas.openxmlformats.org/officeDocument/2006/relationships/image" Target="../media/image44.png"/><Relationship Id="rId30" Type="http://schemas.openxmlformats.org/officeDocument/2006/relationships/image" Target="../media/image45.png"/><Relationship Id="rId31" Type="http://schemas.openxmlformats.org/officeDocument/2006/relationships/image" Target="../media/image46.png"/><Relationship Id="rId32" Type="http://schemas.openxmlformats.org/officeDocument/2006/relationships/image" Target="../media/image47.png"/><Relationship Id="rId33" Type="http://schemas.openxmlformats.org/officeDocument/2006/relationships/image" Target="../media/image48.jpeg"/><Relationship Id="rId34" Type="http://schemas.openxmlformats.org/officeDocument/2006/relationships/image" Target="../media/image49.jpeg"/><Relationship Id="rId35" Type="http://schemas.openxmlformats.org/officeDocument/2006/relationships/image" Target="../media/image50.jpeg"/><Relationship Id="rId36" Type="http://schemas.openxmlformats.org/officeDocument/2006/relationships/image" Target="../media/image51.jpeg"/><Relationship Id="rId37" Type="http://schemas.openxmlformats.org/officeDocument/2006/relationships/image" Target="../media/image52.png"/><Relationship Id="rId38" Type="http://schemas.openxmlformats.org/officeDocument/2006/relationships/image" Target="../media/image53.png"/><Relationship Id="rId39" Type="http://schemas.openxmlformats.org/officeDocument/2006/relationships/image" Target="../media/image54.png"/><Relationship Id="rId40" Type="http://schemas.openxmlformats.org/officeDocument/2006/relationships/image" Target="../media/image55.png"/><Relationship Id="rId41" Type="http://schemas.openxmlformats.org/officeDocument/2006/relationships/slideLayout" Target="../slideLayouts/slideLayout1.xml"/><Relationship Id="rId42" Type="http://schemas.openxmlformats.org/officeDocument/2006/relationships/notesSlide" Target="../notesSlides/notesSlide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29"/>
          <p:cNvSpPr/>
          <p:nvPr/>
        </p:nvSpPr>
        <p:spPr>
          <a:xfrm>
            <a:off x="138240" y="12600"/>
            <a:ext cx="72244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Times New Roman"/>
                <a:ea typeface="Calibri"/>
              </a:rPr>
              <a:t>Additional file 2: Figure  S2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42 - TextBox"/>
          <p:cNvSpPr/>
          <p:nvPr/>
        </p:nvSpPr>
        <p:spPr>
          <a:xfrm>
            <a:off x="225360" y="431640"/>
            <a:ext cx="584280" cy="396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42 - TextBox"/>
          <p:cNvSpPr/>
          <p:nvPr/>
        </p:nvSpPr>
        <p:spPr>
          <a:xfrm>
            <a:off x="297000" y="4667400"/>
            <a:ext cx="583920" cy="396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42 - TextBox"/>
          <p:cNvSpPr/>
          <p:nvPr/>
        </p:nvSpPr>
        <p:spPr>
          <a:xfrm>
            <a:off x="9226440" y="504720"/>
            <a:ext cx="584280" cy="396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Εικόνα 2" descr=""/>
          <p:cNvPicPr/>
          <p:nvPr/>
        </p:nvPicPr>
        <p:blipFill>
          <a:blip r:embed="rId1"/>
          <a:stretch/>
        </p:blipFill>
        <p:spPr>
          <a:xfrm>
            <a:off x="9766440" y="1201680"/>
            <a:ext cx="3644640" cy="3068640"/>
          </a:xfrm>
          <a:prstGeom prst="rect">
            <a:avLst/>
          </a:prstGeom>
          <a:ln w="0">
            <a:noFill/>
          </a:ln>
        </p:spPr>
      </p:pic>
      <p:pic>
        <p:nvPicPr>
          <p:cNvPr id="53" name="Εικόνα 2" descr=""/>
          <p:cNvPicPr/>
          <p:nvPr/>
        </p:nvPicPr>
        <p:blipFill>
          <a:blip r:embed="rId2"/>
          <a:stretch/>
        </p:blipFill>
        <p:spPr>
          <a:xfrm>
            <a:off x="831960" y="777960"/>
            <a:ext cx="3024000" cy="3759120"/>
          </a:xfrm>
          <a:prstGeom prst="rect">
            <a:avLst/>
          </a:prstGeom>
          <a:ln w="0">
            <a:noFill/>
          </a:ln>
        </p:spPr>
      </p:pic>
      <p:pic>
        <p:nvPicPr>
          <p:cNvPr id="54" name="Εικόνα 4" descr=""/>
          <p:cNvPicPr/>
          <p:nvPr/>
        </p:nvPicPr>
        <p:blipFill>
          <a:blip r:embed="rId3"/>
          <a:stretch/>
        </p:blipFill>
        <p:spPr>
          <a:xfrm>
            <a:off x="5273640" y="811080"/>
            <a:ext cx="3024360" cy="3759480"/>
          </a:xfrm>
          <a:prstGeom prst="rect">
            <a:avLst/>
          </a:prstGeom>
          <a:ln w="0">
            <a:noFill/>
          </a:ln>
        </p:spPr>
      </p:pic>
      <p:grpSp>
        <p:nvGrpSpPr>
          <p:cNvPr id="55" name="Ομάδα 17"/>
          <p:cNvGrpSpPr/>
          <p:nvPr/>
        </p:nvGrpSpPr>
        <p:grpSpPr>
          <a:xfrm>
            <a:off x="1309680" y="4799160"/>
            <a:ext cx="11380680" cy="12376080"/>
            <a:chOff x="1309680" y="4799160"/>
            <a:chExt cx="11380680" cy="12376080"/>
          </a:xfrm>
        </p:grpSpPr>
        <p:sp>
          <p:nvSpPr>
            <p:cNvPr id="56" name="TextBox 4"/>
            <p:cNvSpPr/>
            <p:nvPr/>
          </p:nvSpPr>
          <p:spPr>
            <a:xfrm>
              <a:off x="4505040" y="4799160"/>
              <a:ext cx="217476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DA-MB-231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Box 4"/>
            <p:cNvSpPr/>
            <p:nvPr/>
          </p:nvSpPr>
          <p:spPr>
            <a:xfrm>
              <a:off x="1639800" y="4799160"/>
              <a:ext cx="185544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CF</a:t>
              </a:r>
              <a:r>
                <a:rPr b="1" lang="el-GR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10</a:t>
              </a:r>
              <a:r>
                <a:rPr b="1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Box 4"/>
            <p:cNvSpPr/>
            <p:nvPr/>
          </p:nvSpPr>
          <p:spPr>
            <a:xfrm>
              <a:off x="7814160" y="4799160"/>
              <a:ext cx="217476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DA-MB-468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Box 4"/>
            <p:cNvSpPr/>
            <p:nvPr/>
          </p:nvSpPr>
          <p:spPr>
            <a:xfrm>
              <a:off x="10454760" y="4799160"/>
              <a:ext cx="217476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S578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0" name="Εικόνα 3" descr=""/>
            <p:cNvPicPr/>
            <p:nvPr/>
          </p:nvPicPr>
          <p:blipFill>
            <a:blip r:embed="rId4"/>
            <a:srcRect l="0" t="4183" r="0" b="0"/>
            <a:stretch/>
          </p:blipFill>
          <p:spPr>
            <a:xfrm>
              <a:off x="1309680" y="5357160"/>
              <a:ext cx="2248560" cy="3841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1" name="Εικόνα 6" descr=""/>
            <p:cNvPicPr/>
            <p:nvPr/>
          </p:nvPicPr>
          <p:blipFill>
            <a:blip r:embed="rId5"/>
            <a:srcRect l="0" t="5931" r="0" b="0"/>
            <a:stretch/>
          </p:blipFill>
          <p:spPr>
            <a:xfrm>
              <a:off x="1321920" y="9271800"/>
              <a:ext cx="2236320" cy="3821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2" name="Εικόνα 9" descr=""/>
            <p:cNvPicPr/>
            <p:nvPr/>
          </p:nvPicPr>
          <p:blipFill>
            <a:blip r:embed="rId6"/>
            <a:srcRect l="0" t="4694" r="0" b="0"/>
            <a:stretch/>
          </p:blipFill>
          <p:spPr>
            <a:xfrm>
              <a:off x="1347120" y="13353840"/>
              <a:ext cx="2211120" cy="3821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3" name="Εικόνα 13" descr=""/>
            <p:cNvPicPr/>
            <p:nvPr/>
          </p:nvPicPr>
          <p:blipFill>
            <a:blip r:embed="rId7"/>
            <a:srcRect l="0" t="4893" r="0" b="0"/>
            <a:stretch/>
          </p:blipFill>
          <p:spPr>
            <a:xfrm>
              <a:off x="4161960" y="5439960"/>
              <a:ext cx="2211120" cy="3805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4" name="Εικόνα 19" descr=""/>
            <p:cNvPicPr/>
            <p:nvPr/>
          </p:nvPicPr>
          <p:blipFill>
            <a:blip r:embed="rId8"/>
            <a:srcRect l="0" t="5748" r="0" b="0"/>
            <a:stretch/>
          </p:blipFill>
          <p:spPr>
            <a:xfrm>
              <a:off x="4124520" y="13353840"/>
              <a:ext cx="2248560" cy="3821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5" name="Εικόνα 22" descr=""/>
            <p:cNvPicPr/>
            <p:nvPr/>
          </p:nvPicPr>
          <p:blipFill>
            <a:blip r:embed="rId9"/>
            <a:srcRect l="0" t="4893" r="0" b="0"/>
            <a:stretch/>
          </p:blipFill>
          <p:spPr>
            <a:xfrm>
              <a:off x="4124520" y="9262800"/>
              <a:ext cx="2248560" cy="3805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6" name="Εικόνα 2" descr=""/>
            <p:cNvPicPr/>
            <p:nvPr/>
          </p:nvPicPr>
          <p:blipFill>
            <a:blip r:embed="rId10"/>
            <a:srcRect l="0" t="4354" r="0" b="0"/>
            <a:stretch/>
          </p:blipFill>
          <p:spPr>
            <a:xfrm>
              <a:off x="10344240" y="9284760"/>
              <a:ext cx="2145600" cy="3686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7" name="Εικόνα 5" descr=""/>
            <p:cNvPicPr/>
            <p:nvPr/>
          </p:nvPicPr>
          <p:blipFill>
            <a:blip r:embed="rId11"/>
            <a:srcRect l="0" t="5276" r="0" b="0"/>
            <a:stretch/>
          </p:blipFill>
          <p:spPr>
            <a:xfrm>
              <a:off x="10295280" y="5372280"/>
              <a:ext cx="2243160" cy="3854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8" name="Εικόνα 8" descr=""/>
            <p:cNvPicPr/>
            <p:nvPr/>
          </p:nvPicPr>
          <p:blipFill>
            <a:blip r:embed="rId12"/>
            <a:srcRect l="0" t="5276" r="0" b="0"/>
            <a:stretch/>
          </p:blipFill>
          <p:spPr>
            <a:xfrm>
              <a:off x="10429920" y="13223520"/>
              <a:ext cx="2260440" cy="3854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9" name="Εικόνα 14" descr=""/>
            <p:cNvPicPr/>
            <p:nvPr/>
          </p:nvPicPr>
          <p:blipFill>
            <a:blip r:embed="rId13"/>
            <a:srcRect l="0" t="5136" r="0" b="0"/>
            <a:stretch/>
          </p:blipFill>
          <p:spPr>
            <a:xfrm>
              <a:off x="7264440" y="5346000"/>
              <a:ext cx="2268720" cy="3899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0" name="Εικόνα 16" descr=""/>
            <p:cNvPicPr/>
            <p:nvPr/>
          </p:nvPicPr>
          <p:blipFill>
            <a:blip r:embed="rId14"/>
            <a:srcRect l="0" t="5468" r="0" b="0"/>
            <a:stretch/>
          </p:blipFill>
          <p:spPr>
            <a:xfrm>
              <a:off x="7228440" y="13279320"/>
              <a:ext cx="2251800" cy="3854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1" name="Εικόνα 11" descr=""/>
            <p:cNvPicPr/>
            <p:nvPr/>
          </p:nvPicPr>
          <p:blipFill>
            <a:blip r:embed="rId15"/>
            <a:srcRect l="0" t="5276" r="0" b="0"/>
            <a:stretch/>
          </p:blipFill>
          <p:spPr>
            <a:xfrm>
              <a:off x="7264080" y="9195840"/>
              <a:ext cx="2260440" cy="385416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2" name="Ομάδα 12"/>
          <p:cNvGrpSpPr/>
          <p:nvPr/>
        </p:nvGrpSpPr>
        <p:grpSpPr>
          <a:xfrm>
            <a:off x="122400" y="5518080"/>
            <a:ext cx="13487400" cy="10783800"/>
            <a:chOff x="122400" y="5518080"/>
            <a:chExt cx="13487400" cy="10783800"/>
          </a:xfrm>
        </p:grpSpPr>
        <p:grpSp>
          <p:nvGrpSpPr>
            <p:cNvPr id="73" name="Ομάδα 1"/>
            <p:cNvGrpSpPr/>
            <p:nvPr/>
          </p:nvGrpSpPr>
          <p:grpSpPr>
            <a:xfrm>
              <a:off x="122400" y="5862240"/>
              <a:ext cx="13487400" cy="6083280"/>
              <a:chOff x="122400" y="5862240"/>
              <a:chExt cx="13487400" cy="6083280"/>
            </a:xfrm>
          </p:grpSpPr>
          <p:sp>
            <p:nvSpPr>
              <p:cNvPr id="74" name="TextBox 4"/>
              <p:cNvSpPr/>
              <p:nvPr/>
            </p:nvSpPr>
            <p:spPr>
              <a:xfrm>
                <a:off x="4441320" y="5862240"/>
                <a:ext cx="221580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776240"/>
                    <a:tab algn="l" pos="3552840"/>
                    <a:tab algn="l" pos="5329080"/>
                    <a:tab algn="l" pos="7105680"/>
                    <a:tab algn="l" pos="8881920"/>
                    <a:tab algn="l" pos="1065852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DA-MB-231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TextBox 4"/>
              <p:cNvSpPr/>
              <p:nvPr/>
            </p:nvSpPr>
            <p:spPr>
              <a:xfrm>
                <a:off x="1161720" y="5862240"/>
                <a:ext cx="18907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776240"/>
                    <a:tab algn="l" pos="3552840"/>
                    <a:tab algn="l" pos="5329080"/>
                    <a:tab algn="l" pos="7105680"/>
                    <a:tab algn="l" pos="8881920"/>
                    <a:tab algn="l" pos="1065852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CF</a:t>
                </a:r>
                <a:r>
                  <a:rPr b="1" lang="el-GR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10</a:t>
                </a:r>
                <a:r>
                  <a:rPr b="1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A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84 - TextBox"/>
              <p:cNvSpPr/>
              <p:nvPr/>
            </p:nvSpPr>
            <p:spPr>
              <a:xfrm>
                <a:off x="5120280" y="6214680"/>
                <a:ext cx="18165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776240"/>
                    <a:tab algn="l" pos="3552840"/>
                    <a:tab algn="l" pos="5329080"/>
                    <a:tab algn="l" pos="7105680"/>
                    <a:tab algn="l" pos="8881920"/>
                    <a:tab algn="l" pos="1065852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ERGE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108 - TextBox"/>
              <p:cNvSpPr/>
              <p:nvPr/>
            </p:nvSpPr>
            <p:spPr>
              <a:xfrm>
                <a:off x="3668040" y="6239520"/>
                <a:ext cx="1563840" cy="27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5160" rIns="65160" tIns="32760" bIns="3276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776240"/>
                    <a:tab algn="l" pos="3552840"/>
                    <a:tab algn="l" pos="5329080"/>
                    <a:tab algn="l" pos="7105680"/>
                    <a:tab algn="l" pos="8881920"/>
                    <a:tab algn="l" pos="10658520"/>
                  </a:tabLst>
                </a:pPr>
                <a:r>
                  <a:rPr b="1" lang="el-GR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γΗ2ΑΧ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76 - Ευθεία γραμμή σύνδεσης"/>
              <p:cNvSpPr/>
              <p:nvPr/>
            </p:nvSpPr>
            <p:spPr>
              <a:xfrm>
                <a:off x="466560" y="6209640"/>
                <a:ext cx="32050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3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84 - TextBox"/>
              <p:cNvSpPr/>
              <p:nvPr/>
            </p:nvSpPr>
            <p:spPr>
              <a:xfrm>
                <a:off x="1780200" y="6228720"/>
                <a:ext cx="18147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776240"/>
                    <a:tab algn="l" pos="3552840"/>
                    <a:tab algn="l" pos="5329080"/>
                    <a:tab algn="l" pos="7105680"/>
                    <a:tab algn="l" pos="8881920"/>
                    <a:tab algn="l" pos="1065852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ERGE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108 - TextBox"/>
              <p:cNvSpPr/>
              <p:nvPr/>
            </p:nvSpPr>
            <p:spPr>
              <a:xfrm>
                <a:off x="400320" y="6232320"/>
                <a:ext cx="1563840" cy="27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5160" rIns="65160" tIns="32760" bIns="3276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776240"/>
                    <a:tab algn="l" pos="3552840"/>
                    <a:tab algn="l" pos="5329080"/>
                    <a:tab algn="l" pos="7105680"/>
                    <a:tab algn="l" pos="8881920"/>
                    <a:tab algn="l" pos="10658520"/>
                  </a:tabLst>
                </a:pPr>
                <a:r>
                  <a:rPr b="1" lang="el-GR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γΗ2ΑΧ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108 - TextBox"/>
              <p:cNvSpPr/>
              <p:nvPr/>
            </p:nvSpPr>
            <p:spPr>
              <a:xfrm rot="16200000">
                <a:off x="-185040" y="8385840"/>
                <a:ext cx="869040" cy="253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9960" rIns="39960" tIns="20160" bIns="2016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776240"/>
                    <a:tab algn="l" pos="3552840"/>
                    <a:tab algn="l" pos="5329080"/>
                    <a:tab algn="l" pos="7105680"/>
                    <a:tab algn="l" pos="8881920"/>
                    <a:tab algn="l" pos="1065852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TS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108 - TextBox"/>
              <p:cNvSpPr/>
              <p:nvPr/>
            </p:nvSpPr>
            <p:spPr>
              <a:xfrm rot="16200000">
                <a:off x="-185040" y="9693360"/>
                <a:ext cx="869040" cy="253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9960" rIns="39960" tIns="20160" bIns="2016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776240"/>
                    <a:tab algn="l" pos="3552840"/>
                    <a:tab algn="l" pos="5329080"/>
                    <a:tab algn="l" pos="7105680"/>
                    <a:tab algn="l" pos="8881920"/>
                    <a:tab algn="l" pos="1065852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DXR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108 - TextBox"/>
              <p:cNvSpPr/>
              <p:nvPr/>
            </p:nvSpPr>
            <p:spPr>
              <a:xfrm rot="16200000">
                <a:off x="-428760" y="11010960"/>
                <a:ext cx="1356840" cy="253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9960" rIns="39960" tIns="20160" bIns="2016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776240"/>
                    <a:tab algn="l" pos="3552840"/>
                    <a:tab algn="l" pos="5329080"/>
                    <a:tab algn="l" pos="7105680"/>
                    <a:tab algn="l" pos="8881920"/>
                    <a:tab algn="l" pos="1065852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TS+DXR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108 - TextBox"/>
              <p:cNvSpPr/>
              <p:nvPr/>
            </p:nvSpPr>
            <p:spPr>
              <a:xfrm rot="16200000">
                <a:off x="-185040" y="7202160"/>
                <a:ext cx="869040" cy="253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9960" rIns="39960" tIns="20160" bIns="2016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776240"/>
                    <a:tab algn="l" pos="3552840"/>
                    <a:tab algn="l" pos="5329080"/>
                    <a:tab algn="l" pos="7105680"/>
                    <a:tab algn="l" pos="8881920"/>
                    <a:tab algn="l" pos="1065852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TRL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76 - Ευθεία γραμμή σύνδεσης"/>
              <p:cNvSpPr/>
              <p:nvPr/>
            </p:nvSpPr>
            <p:spPr>
              <a:xfrm>
                <a:off x="3721320" y="6209640"/>
                <a:ext cx="32036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3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TextBox 4"/>
              <p:cNvSpPr/>
              <p:nvPr/>
            </p:nvSpPr>
            <p:spPr>
              <a:xfrm>
                <a:off x="7813080" y="5862240"/>
                <a:ext cx="221580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776240"/>
                    <a:tab algn="l" pos="3552840"/>
                    <a:tab algn="l" pos="5329080"/>
                    <a:tab algn="l" pos="7105680"/>
                    <a:tab algn="l" pos="8881920"/>
                    <a:tab algn="l" pos="1065852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DA-MB-468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84 - TextBox"/>
              <p:cNvSpPr/>
              <p:nvPr/>
            </p:nvSpPr>
            <p:spPr>
              <a:xfrm>
                <a:off x="8491680" y="6214680"/>
                <a:ext cx="18165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776240"/>
                    <a:tab algn="l" pos="3552840"/>
                    <a:tab algn="l" pos="5329080"/>
                    <a:tab algn="l" pos="7105680"/>
                    <a:tab algn="l" pos="8881920"/>
                    <a:tab algn="l" pos="1065852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ERGE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108 - TextBox"/>
              <p:cNvSpPr/>
              <p:nvPr/>
            </p:nvSpPr>
            <p:spPr>
              <a:xfrm>
                <a:off x="7039800" y="6239520"/>
                <a:ext cx="1563840" cy="27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5160" rIns="65160" tIns="32760" bIns="3276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776240"/>
                    <a:tab algn="l" pos="3552840"/>
                    <a:tab algn="l" pos="5329080"/>
                    <a:tab algn="l" pos="7105680"/>
                    <a:tab algn="l" pos="8881920"/>
                    <a:tab algn="l" pos="10658520"/>
                  </a:tabLst>
                </a:pPr>
                <a:r>
                  <a:rPr b="1" lang="el-GR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γΗ2ΑΧ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76 - Ευθεία γραμμή σύνδεσης"/>
              <p:cNvSpPr/>
              <p:nvPr/>
            </p:nvSpPr>
            <p:spPr>
              <a:xfrm>
                <a:off x="7075800" y="6209640"/>
                <a:ext cx="32050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3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TextBox 4"/>
              <p:cNvSpPr/>
              <p:nvPr/>
            </p:nvSpPr>
            <p:spPr>
              <a:xfrm>
                <a:off x="10848960" y="5862240"/>
                <a:ext cx="221580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776240"/>
                    <a:tab algn="l" pos="3552840"/>
                    <a:tab algn="l" pos="5329080"/>
                    <a:tab algn="l" pos="7105680"/>
                    <a:tab algn="l" pos="8881920"/>
                    <a:tab algn="l" pos="1065852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HS578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84 - TextBox"/>
              <p:cNvSpPr/>
              <p:nvPr/>
            </p:nvSpPr>
            <p:spPr>
              <a:xfrm>
                <a:off x="11715120" y="6228720"/>
                <a:ext cx="18165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776240"/>
                    <a:tab algn="l" pos="3552840"/>
                    <a:tab algn="l" pos="5329080"/>
                    <a:tab algn="l" pos="7105680"/>
                    <a:tab algn="l" pos="8881920"/>
                    <a:tab algn="l" pos="1065852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ERGE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108 - TextBox"/>
              <p:cNvSpPr/>
              <p:nvPr/>
            </p:nvSpPr>
            <p:spPr>
              <a:xfrm>
                <a:off x="10262880" y="6253560"/>
                <a:ext cx="1563840" cy="27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5160" rIns="65160" tIns="32760" bIns="3276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1776240"/>
                    <a:tab algn="l" pos="3552840"/>
                    <a:tab algn="l" pos="5329080"/>
                    <a:tab algn="l" pos="7105680"/>
                    <a:tab algn="l" pos="8881920"/>
                    <a:tab algn="l" pos="10658520"/>
                  </a:tabLst>
                </a:pPr>
                <a:r>
                  <a:rPr b="1" lang="el-GR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γΗ2ΑΧ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76 - Ευθεία γραμμή σύνδεσης"/>
              <p:cNvSpPr/>
              <p:nvPr/>
            </p:nvSpPr>
            <p:spPr>
              <a:xfrm>
                <a:off x="10365120" y="6209640"/>
                <a:ext cx="32050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3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94" name="Picture 38" descr="A green leaf on a black background&#10;&#10;Description automatically generated with low confidence"/>
              <p:cNvPicPr/>
              <p:nvPr/>
            </p:nvPicPr>
            <p:blipFill>
              <a:blip r:embed="rId1"/>
              <a:stretch/>
            </p:blipFill>
            <p:spPr>
              <a:xfrm>
                <a:off x="438480" y="9248040"/>
                <a:ext cx="1605600" cy="1245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5" name="Picture 40" descr="A picture containing night sky&#10;&#10;Description automatically generated"/>
              <p:cNvPicPr/>
              <p:nvPr/>
            </p:nvPicPr>
            <p:blipFill>
              <a:blip r:embed="rId2"/>
              <a:stretch/>
            </p:blipFill>
            <p:spPr>
              <a:xfrm>
                <a:off x="2076480" y="9248040"/>
                <a:ext cx="1605600" cy="1245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6" name="Picture 43" descr="A picture containing night sky&#10;&#10;Description automatically generated"/>
              <p:cNvPicPr/>
              <p:nvPr/>
            </p:nvPicPr>
            <p:blipFill>
              <a:blip r:embed="rId3"/>
              <a:stretch/>
            </p:blipFill>
            <p:spPr>
              <a:xfrm>
                <a:off x="425880" y="6617160"/>
                <a:ext cx="1605600" cy="1245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7" name="Picture 45" descr="A group of blue lights&#10;&#10;Description automatically generated with low confidence"/>
              <p:cNvPicPr/>
              <p:nvPr/>
            </p:nvPicPr>
            <p:blipFill>
              <a:blip r:embed="rId4"/>
              <a:stretch/>
            </p:blipFill>
            <p:spPr>
              <a:xfrm>
                <a:off x="2066040" y="6617160"/>
                <a:ext cx="1605600" cy="1245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8" name="Picture 53" descr="A picture containing night sky&#10;&#10;Description automatically generated"/>
              <p:cNvPicPr/>
              <p:nvPr/>
            </p:nvPicPr>
            <p:blipFill>
              <a:blip r:embed="rId5"/>
              <a:stretch/>
            </p:blipFill>
            <p:spPr>
              <a:xfrm>
                <a:off x="436680" y="10578240"/>
                <a:ext cx="1605600" cy="1245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99" name="Picture 55" descr="A picture containing computer, night sky&#10;&#10;Description automatically generated"/>
              <p:cNvPicPr/>
              <p:nvPr/>
            </p:nvPicPr>
            <p:blipFill>
              <a:blip r:embed="rId6"/>
              <a:stretch/>
            </p:blipFill>
            <p:spPr>
              <a:xfrm>
                <a:off x="2077200" y="10578240"/>
                <a:ext cx="1605600" cy="1245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00" name="Picture 58" descr="A picture containing star, dark, outdoor object, night sky&#10;&#10;Description automatically generated"/>
              <p:cNvPicPr/>
              <p:nvPr/>
            </p:nvPicPr>
            <p:blipFill>
              <a:blip r:embed="rId7"/>
              <a:stretch/>
            </p:blipFill>
            <p:spPr>
              <a:xfrm>
                <a:off x="3729600" y="6617160"/>
                <a:ext cx="1605600" cy="1245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01" name="Picture 60" descr="A picture containing indoor, black, dark&#10;&#10;Description automatically generated"/>
              <p:cNvPicPr/>
              <p:nvPr/>
            </p:nvPicPr>
            <p:blipFill>
              <a:blip r:embed="rId8"/>
              <a:stretch/>
            </p:blipFill>
            <p:spPr>
              <a:xfrm>
                <a:off x="5369760" y="6617160"/>
                <a:ext cx="1605600" cy="1245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02" name="Picture 62" descr="A picture containing dark, night sky&#10;&#10;Description automatically generated"/>
              <p:cNvPicPr/>
              <p:nvPr/>
            </p:nvPicPr>
            <p:blipFill>
              <a:blip r:embed="rId9"/>
              <a:stretch/>
            </p:blipFill>
            <p:spPr>
              <a:xfrm>
                <a:off x="3738600" y="9253080"/>
                <a:ext cx="1605600" cy="1245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03" name="Picture 64" descr="A picture containing night sky&#10;&#10;Description automatically generated"/>
              <p:cNvPicPr/>
              <p:nvPr/>
            </p:nvPicPr>
            <p:blipFill>
              <a:blip r:embed="rId10"/>
              <a:stretch/>
            </p:blipFill>
            <p:spPr>
              <a:xfrm>
                <a:off x="5382360" y="9248040"/>
                <a:ext cx="1605600" cy="1245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04" name="Picture 70" descr="A picture containing dark, night sky&#10;&#10;Description automatically generated"/>
              <p:cNvPicPr/>
              <p:nvPr/>
            </p:nvPicPr>
            <p:blipFill>
              <a:blip r:embed="rId11"/>
              <a:stretch/>
            </p:blipFill>
            <p:spPr>
              <a:xfrm>
                <a:off x="3729600" y="10578240"/>
                <a:ext cx="1605600" cy="1245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05" name="Picture 72" descr="A picture containing night sky&#10;&#10;Description automatically generated"/>
              <p:cNvPicPr/>
              <p:nvPr/>
            </p:nvPicPr>
            <p:blipFill>
              <a:blip r:embed="rId12"/>
              <a:stretch/>
            </p:blipFill>
            <p:spPr>
              <a:xfrm>
                <a:off x="5382360" y="10578240"/>
                <a:ext cx="1605600" cy="1245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06" name="Picture 74" descr="A picture containing night sky&#10;&#10;Description automatically generated"/>
              <p:cNvPicPr/>
              <p:nvPr/>
            </p:nvPicPr>
            <p:blipFill>
              <a:blip r:embed="rId13"/>
              <a:stretch/>
            </p:blipFill>
            <p:spPr>
              <a:xfrm>
                <a:off x="10351440" y="6606360"/>
                <a:ext cx="1605600" cy="1245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07" name="Picture 76" descr="A group of blue jellyfish&#10;&#10;Description automatically generated with medium confidence"/>
              <p:cNvPicPr/>
              <p:nvPr/>
            </p:nvPicPr>
            <p:blipFill>
              <a:blip r:embed="rId14"/>
              <a:stretch/>
            </p:blipFill>
            <p:spPr>
              <a:xfrm>
                <a:off x="11988000" y="6606360"/>
                <a:ext cx="1605600" cy="1245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08" name="Picture 78" descr="A picture containing blur&#10;&#10;Description automatically generated"/>
              <p:cNvPicPr/>
              <p:nvPr/>
            </p:nvPicPr>
            <p:blipFill>
              <a:blip r:embed="rId15"/>
              <a:stretch/>
            </p:blipFill>
            <p:spPr>
              <a:xfrm>
                <a:off x="12000240" y="9248040"/>
                <a:ext cx="1605600" cy="1245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09" name="Picture 80" descr="A picture containing dark, night sky&#10;&#10;Description automatically generated"/>
              <p:cNvPicPr/>
              <p:nvPr/>
            </p:nvPicPr>
            <p:blipFill>
              <a:blip r:embed="rId16"/>
              <a:stretch/>
            </p:blipFill>
            <p:spPr>
              <a:xfrm>
                <a:off x="10363680" y="9248040"/>
                <a:ext cx="1605600" cy="1245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0" name="Picture 82" descr="A picture containing blur&#10;&#10;Description automatically generated"/>
              <p:cNvPicPr/>
              <p:nvPr/>
            </p:nvPicPr>
            <p:blipFill>
              <a:blip r:embed="rId17"/>
              <a:stretch/>
            </p:blipFill>
            <p:spPr>
              <a:xfrm>
                <a:off x="12004200" y="10578240"/>
                <a:ext cx="1605600" cy="1245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1" name="Picture 84" descr="A group of trees at night&#10;&#10;Description automatically generated with low confidence"/>
              <p:cNvPicPr/>
              <p:nvPr/>
            </p:nvPicPr>
            <p:blipFill>
              <a:blip r:embed="rId18"/>
              <a:stretch/>
            </p:blipFill>
            <p:spPr>
              <a:xfrm>
                <a:off x="10359360" y="10578240"/>
                <a:ext cx="1605600" cy="1245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2" name="Picture 86" descr="A picture containing indoor, dark, night sky&#10;&#10;Description automatically generated"/>
              <p:cNvPicPr/>
              <p:nvPr/>
            </p:nvPicPr>
            <p:blipFill>
              <a:blip r:embed="rId19"/>
              <a:stretch/>
            </p:blipFill>
            <p:spPr>
              <a:xfrm>
                <a:off x="10355400" y="7914600"/>
                <a:ext cx="1605600" cy="1245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3" name="Picture 88" descr="A picture containing dark, night sky&#10;&#10;Description automatically generated"/>
              <p:cNvPicPr/>
              <p:nvPr/>
            </p:nvPicPr>
            <p:blipFill>
              <a:blip r:embed="rId20"/>
              <a:stretch/>
            </p:blipFill>
            <p:spPr>
              <a:xfrm>
                <a:off x="12000240" y="7920720"/>
                <a:ext cx="1605600" cy="1245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4" name="Picture 92" descr="A picture containing dark, night sky&#10;&#10;Description automatically generated"/>
              <p:cNvPicPr/>
              <p:nvPr/>
            </p:nvPicPr>
            <p:blipFill>
              <a:blip r:embed="rId21"/>
              <a:stretch/>
            </p:blipFill>
            <p:spPr>
              <a:xfrm>
                <a:off x="3750840" y="7926840"/>
                <a:ext cx="1605600" cy="1245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5" name="Picture 94" descr="A picture containing light, dark&#10;&#10;Description automatically generated"/>
              <p:cNvPicPr/>
              <p:nvPr/>
            </p:nvPicPr>
            <p:blipFill>
              <a:blip r:embed="rId22"/>
              <a:stretch/>
            </p:blipFill>
            <p:spPr>
              <a:xfrm>
                <a:off x="5381640" y="7929000"/>
                <a:ext cx="1605600" cy="1245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6" name="Picture 96" descr="A picture containing black, dark, star, night sky&#10;&#10;Description automatically generated"/>
              <p:cNvPicPr/>
              <p:nvPr/>
            </p:nvPicPr>
            <p:blipFill>
              <a:blip r:embed="rId23"/>
              <a:stretch/>
            </p:blipFill>
            <p:spPr>
              <a:xfrm>
                <a:off x="7040520" y="6606360"/>
                <a:ext cx="1605600" cy="1245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7" name="Picture 98" descr="A picture containing night sky&#10;&#10;Description automatically generated"/>
              <p:cNvPicPr/>
              <p:nvPr/>
            </p:nvPicPr>
            <p:blipFill>
              <a:blip r:embed="rId24"/>
              <a:stretch/>
            </p:blipFill>
            <p:spPr>
              <a:xfrm>
                <a:off x="8685360" y="6606360"/>
                <a:ext cx="1605600" cy="1245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8" name="Picture 104" descr="A picture containing dark, night sky&#10;&#10;Description automatically generated"/>
              <p:cNvPicPr/>
              <p:nvPr/>
            </p:nvPicPr>
            <p:blipFill>
              <a:blip r:embed="rId25"/>
              <a:stretch/>
            </p:blipFill>
            <p:spPr>
              <a:xfrm>
                <a:off x="7043760" y="10581840"/>
                <a:ext cx="1605600" cy="1245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9" name="Picture 106" descr="A group of blue lights&#10;&#10;Description automatically generated with low confidence"/>
              <p:cNvPicPr/>
              <p:nvPr/>
            </p:nvPicPr>
            <p:blipFill>
              <a:blip r:embed="rId26"/>
              <a:stretch/>
            </p:blipFill>
            <p:spPr>
              <a:xfrm>
                <a:off x="8691480" y="10577880"/>
                <a:ext cx="1605600" cy="1245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20" name="Picture 110" descr="A picture containing night sky&#10;&#10;Description automatically generated"/>
              <p:cNvPicPr/>
              <p:nvPr/>
            </p:nvPicPr>
            <p:blipFill>
              <a:blip r:embed="rId27"/>
              <a:stretch/>
            </p:blipFill>
            <p:spPr>
              <a:xfrm>
                <a:off x="8694720" y="9246960"/>
                <a:ext cx="1605600" cy="1245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21" name="Picture 112" descr="A picture containing night sky&#10;&#10;Description automatically generated"/>
              <p:cNvPicPr/>
              <p:nvPr/>
            </p:nvPicPr>
            <p:blipFill>
              <a:blip r:embed="rId28"/>
              <a:stretch/>
            </p:blipFill>
            <p:spPr>
              <a:xfrm>
                <a:off x="7035120" y="9248040"/>
                <a:ext cx="1605600" cy="1245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22" name="Picture 114" descr="A picture containing star, dark, night sky&#10;&#10;Description automatically generated"/>
              <p:cNvPicPr/>
              <p:nvPr/>
            </p:nvPicPr>
            <p:blipFill>
              <a:blip r:embed="rId29"/>
              <a:stretch/>
            </p:blipFill>
            <p:spPr>
              <a:xfrm>
                <a:off x="7043760" y="7920720"/>
                <a:ext cx="1605600" cy="1245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23" name="Picture 116" descr=""/>
              <p:cNvPicPr/>
              <p:nvPr/>
            </p:nvPicPr>
            <p:blipFill>
              <a:blip r:embed="rId30"/>
              <a:stretch/>
            </p:blipFill>
            <p:spPr>
              <a:xfrm>
                <a:off x="8678880" y="7924680"/>
                <a:ext cx="1605600" cy="12456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24" name="62 - Ευθεία γραμμή σύνδεσης"/>
              <p:cNvSpPr/>
              <p:nvPr/>
            </p:nvSpPr>
            <p:spPr>
              <a:xfrm>
                <a:off x="12956040" y="11945520"/>
                <a:ext cx="3013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3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5" name="71 - TextBox"/>
            <p:cNvSpPr/>
            <p:nvPr/>
          </p:nvSpPr>
          <p:spPr>
            <a:xfrm>
              <a:off x="210240" y="5518080"/>
              <a:ext cx="387360" cy="396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776240"/>
                  <a:tab algn="l" pos="3552840"/>
                  <a:tab algn="l" pos="5329080"/>
                  <a:tab algn="l" pos="7105680"/>
                  <a:tab algn="l" pos="8881920"/>
                  <a:tab algn="l" pos="10658520"/>
                </a:tabLst>
              </a:pPr>
              <a:r>
                <a:rPr b="1" lang="el-GR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26" name="Picture 26" descr="A picture containing night sky&#10;&#10;Description automatically generated"/>
            <p:cNvPicPr/>
            <p:nvPr/>
          </p:nvPicPr>
          <p:blipFill>
            <a:blip r:embed="rId31"/>
            <a:stretch/>
          </p:blipFill>
          <p:spPr>
            <a:xfrm>
              <a:off x="425520" y="7920000"/>
              <a:ext cx="1604880" cy="1245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7" name="Picture 28" descr="A picture containing computer, dark, night sky&#10;&#10;Description automatically generated"/>
            <p:cNvPicPr/>
            <p:nvPr/>
          </p:nvPicPr>
          <p:blipFill>
            <a:blip r:embed="rId32"/>
            <a:stretch/>
          </p:blipFill>
          <p:spPr>
            <a:xfrm>
              <a:off x="2077920" y="7920000"/>
              <a:ext cx="1604880" cy="1245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8" name="Εικόνα 23559" descr=""/>
            <p:cNvPicPr/>
            <p:nvPr/>
          </p:nvPicPr>
          <p:blipFill>
            <a:blip r:embed="rId33"/>
            <a:stretch/>
          </p:blipFill>
          <p:spPr>
            <a:xfrm>
              <a:off x="10677960" y="12100680"/>
              <a:ext cx="2305080" cy="4145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9" name="Εικόνα 23570" descr=""/>
            <p:cNvPicPr/>
            <p:nvPr/>
          </p:nvPicPr>
          <p:blipFill>
            <a:blip r:embed="rId34"/>
            <a:stretch/>
          </p:blipFill>
          <p:spPr>
            <a:xfrm>
              <a:off x="3964320" y="12065040"/>
              <a:ext cx="2282760" cy="4202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0" name="Εικόνα 23607" descr=""/>
            <p:cNvPicPr/>
            <p:nvPr/>
          </p:nvPicPr>
          <p:blipFill>
            <a:blip r:embed="rId35"/>
            <a:stretch/>
          </p:blipFill>
          <p:spPr>
            <a:xfrm>
              <a:off x="7295040" y="12034800"/>
              <a:ext cx="2330280" cy="4202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1" name="Εικόνα 11" descr=""/>
            <p:cNvPicPr/>
            <p:nvPr/>
          </p:nvPicPr>
          <p:blipFill>
            <a:blip r:embed="rId36"/>
            <a:stretch/>
          </p:blipFill>
          <p:spPr>
            <a:xfrm>
              <a:off x="770040" y="12100680"/>
              <a:ext cx="2282400" cy="420120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32" name="42 - TextBox"/>
          <p:cNvSpPr/>
          <p:nvPr/>
        </p:nvSpPr>
        <p:spPr>
          <a:xfrm>
            <a:off x="177840" y="909720"/>
            <a:ext cx="584280" cy="396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776240"/>
                <a:tab algn="l" pos="3552840"/>
                <a:tab algn="l" pos="5329080"/>
                <a:tab algn="l" pos="7105680"/>
                <a:tab algn="l" pos="8881920"/>
                <a:tab algn="l" pos="1065852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3" name="36 - Ομάδα"/>
          <p:cNvGrpSpPr/>
          <p:nvPr/>
        </p:nvGrpSpPr>
        <p:grpSpPr>
          <a:xfrm>
            <a:off x="274680" y="1542960"/>
            <a:ext cx="13279320" cy="3152880"/>
            <a:chOff x="274680" y="1542960"/>
            <a:chExt cx="13279320" cy="3152880"/>
          </a:xfrm>
        </p:grpSpPr>
        <p:pic>
          <p:nvPicPr>
            <p:cNvPr id="134" name="Picture 30" descr=""/>
            <p:cNvPicPr/>
            <p:nvPr/>
          </p:nvPicPr>
          <p:blipFill>
            <a:blip r:embed="rId37"/>
            <a:stretch/>
          </p:blipFill>
          <p:spPr>
            <a:xfrm>
              <a:off x="3650040" y="1626840"/>
              <a:ext cx="3315240" cy="3069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5" name="Picture 31" descr=""/>
            <p:cNvPicPr/>
            <p:nvPr/>
          </p:nvPicPr>
          <p:blipFill>
            <a:blip r:embed="rId38"/>
            <a:stretch/>
          </p:blipFill>
          <p:spPr>
            <a:xfrm>
              <a:off x="6953040" y="1542960"/>
              <a:ext cx="3315240" cy="3069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6" name="Picture 32" descr=""/>
            <p:cNvPicPr/>
            <p:nvPr/>
          </p:nvPicPr>
          <p:blipFill>
            <a:blip r:embed="rId39"/>
            <a:stretch/>
          </p:blipFill>
          <p:spPr>
            <a:xfrm>
              <a:off x="10238760" y="1563480"/>
              <a:ext cx="3315240" cy="3069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7" name="Picture 33" descr=""/>
            <p:cNvPicPr/>
            <p:nvPr/>
          </p:nvPicPr>
          <p:blipFill>
            <a:blip r:embed="rId40"/>
            <a:stretch/>
          </p:blipFill>
          <p:spPr>
            <a:xfrm>
              <a:off x="274680" y="1626840"/>
              <a:ext cx="3313440" cy="300564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06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11-29T11:22:21Z</dcterms:created>
  <dc:creator>Dell User</dc:creator>
  <dc:description/>
  <dc:language>en-US</dc:language>
  <cp:lastModifiedBy>Priya V.</cp:lastModifiedBy>
  <cp:lastPrinted>2023-01-20T17:09:44Z</cp:lastPrinted>
  <dcterms:modified xsi:type="dcterms:W3CDTF">2023-02-01T03:59:07Z</dcterms:modified>
  <cp:revision>364</cp:revision>
  <dc:subject/>
  <dc:title>PowerPoint Presentation</dc:title>
</cp:coreProperties>
</file>